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6F223-7757-4E37-9E70-B8C741B446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7081D-135F-406A-BBAE-B9F5DD9677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1D3BA-2F28-4AB4-9AD7-29FFB0E69E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7E6B0-EA95-419C-8AD6-3C16DC26EC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867EE-FFF6-4C37-A0EE-80F9FAA89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977C8-E326-4C85-A048-4BA5639BD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7C42B-C1BE-4D6D-AFD1-B905863480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E45E2-984F-47BA-A52F-07B74E30D2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9D100-D083-4C05-A538-D40CDF4580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BB017-AA66-433E-9232-790CB099B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FD16B-75A9-42F3-938D-4A1A31B1C5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E7B32-129E-4B4F-AEDE-133CA6A44E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F2006B-7793-4613-9092-5603AC00A512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ACDA9C-8238-4CFA-8D38-387FA9F3C97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0"/>
          <p:cNvSpPr/>
          <p:nvPr/>
        </p:nvSpPr>
        <p:spPr>
          <a:xfrm rot="16260000">
            <a:off x="2420640" y="6266880"/>
            <a:ext cx="282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6" descr=""/>
          <p:cNvPicPr/>
          <p:nvPr/>
        </p:nvPicPr>
        <p:blipFill>
          <a:blip r:embed="rId1"/>
          <a:stretch/>
        </p:blipFill>
        <p:spPr>
          <a:xfrm>
            <a:off x="857160" y="3247920"/>
            <a:ext cx="2325600" cy="208116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47"/>
          <p:cNvSpPr/>
          <p:nvPr/>
        </p:nvSpPr>
        <p:spPr>
          <a:xfrm>
            <a:off x="2057400" y="5143680"/>
            <a:ext cx="728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57" descr=""/>
          <p:cNvPicPr/>
          <p:nvPr/>
        </p:nvPicPr>
        <p:blipFill>
          <a:blip r:embed="rId2"/>
          <a:stretch/>
        </p:blipFill>
        <p:spPr>
          <a:xfrm>
            <a:off x="801720" y="1014480"/>
            <a:ext cx="2381040" cy="2000160"/>
          </a:xfrm>
          <a:prstGeom prst="rect">
            <a:avLst/>
          </a:prstGeom>
          <a:ln w="0">
            <a:noFill/>
          </a:ln>
        </p:spPr>
      </p:pic>
      <p:grpSp>
        <p:nvGrpSpPr>
          <p:cNvPr id="45" name=""/>
          <p:cNvGrpSpPr/>
          <p:nvPr/>
        </p:nvGrpSpPr>
        <p:grpSpPr>
          <a:xfrm>
            <a:off x="3556080" y="3619440"/>
            <a:ext cx="2376360" cy="1381320"/>
            <a:chOff x="3556080" y="3619440"/>
            <a:chExt cx="2376360" cy="1381320"/>
          </a:xfrm>
        </p:grpSpPr>
        <p:pic>
          <p:nvPicPr>
            <p:cNvPr id="46" name="Picture 51" descr=""/>
            <p:cNvPicPr/>
            <p:nvPr/>
          </p:nvPicPr>
          <p:blipFill>
            <a:blip r:embed="rId3"/>
            <a:stretch/>
          </p:blipFill>
          <p:spPr>
            <a:xfrm>
              <a:off x="4219200" y="3619440"/>
              <a:ext cx="1713240" cy="1381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7" name=""/>
            <p:cNvGrpSpPr/>
            <p:nvPr/>
          </p:nvGrpSpPr>
          <p:grpSpPr>
            <a:xfrm>
              <a:off x="3556080" y="4344840"/>
              <a:ext cx="558000" cy="593280"/>
              <a:chOff x="3556080" y="4344840"/>
              <a:chExt cx="558000" cy="593280"/>
            </a:xfrm>
          </p:grpSpPr>
          <p:sp>
            <p:nvSpPr>
              <p:cNvPr id="48" name="Rectangle 52"/>
              <p:cNvSpPr/>
              <p:nvPr/>
            </p:nvSpPr>
            <p:spPr>
              <a:xfrm>
                <a:off x="3715560" y="4344840"/>
                <a:ext cx="39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BCL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60"/>
              <p:cNvSpPr/>
              <p:nvPr/>
            </p:nvSpPr>
            <p:spPr>
              <a:xfrm>
                <a:off x="3556080" y="4755240"/>
                <a:ext cx="550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0" name=""/>
          <p:cNvGrpSpPr/>
          <p:nvPr/>
        </p:nvGrpSpPr>
        <p:grpSpPr>
          <a:xfrm>
            <a:off x="3611880" y="1341360"/>
            <a:ext cx="2388960" cy="1442880"/>
            <a:chOff x="3611880" y="1341360"/>
            <a:chExt cx="2388960" cy="1442880"/>
          </a:xfrm>
        </p:grpSpPr>
        <p:pic>
          <p:nvPicPr>
            <p:cNvPr id="51" name="Picture 59" descr=""/>
            <p:cNvPicPr/>
            <p:nvPr/>
          </p:nvPicPr>
          <p:blipFill>
            <a:blip r:embed="rId4"/>
            <a:stretch/>
          </p:blipFill>
          <p:spPr>
            <a:xfrm>
              <a:off x="4219560" y="1341360"/>
              <a:ext cx="1781280" cy="143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"/>
            <p:cNvGrpSpPr/>
            <p:nvPr/>
          </p:nvGrpSpPr>
          <p:grpSpPr>
            <a:xfrm>
              <a:off x="3611880" y="2102400"/>
              <a:ext cx="550800" cy="681840"/>
              <a:chOff x="3611880" y="2102400"/>
              <a:chExt cx="550800" cy="681840"/>
            </a:xfrm>
          </p:grpSpPr>
          <p:sp>
            <p:nvSpPr>
              <p:cNvPr id="53" name="Rectangle 53"/>
              <p:cNvSpPr/>
              <p:nvPr/>
            </p:nvSpPr>
            <p:spPr>
              <a:xfrm>
                <a:off x="3611880" y="2601360"/>
                <a:ext cx="550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61"/>
              <p:cNvSpPr/>
              <p:nvPr/>
            </p:nvSpPr>
            <p:spPr>
              <a:xfrm>
                <a:off x="3715920" y="2102400"/>
                <a:ext cx="39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BCL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5" name="Rectangle 62"/>
          <p:cNvSpPr/>
          <p:nvPr/>
        </p:nvSpPr>
        <p:spPr>
          <a:xfrm>
            <a:off x="1928880" y="2816280"/>
            <a:ext cx="780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47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70"/>
          <p:cNvSpPr/>
          <p:nvPr/>
        </p:nvSpPr>
        <p:spPr>
          <a:xfrm>
            <a:off x="285840" y="5396040"/>
            <a:ext cx="6072120" cy="215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. Modulation of the expression of BCL6 in breast cancer cell lines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vitro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(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BCL6 siRNA was transiently transfected into T47D cells to decrease the expression of BCL6. (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BCL6 cDNA was transiently transfected into MCF-7 cells to increase the expression of BCL6. **,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1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2"/>
          <p:cNvSpPr/>
          <p:nvPr/>
        </p:nvSpPr>
        <p:spPr>
          <a:xfrm>
            <a:off x="0" y="120600"/>
            <a:ext cx="231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3"/>
          <p:cNvSpPr/>
          <p:nvPr/>
        </p:nvSpPr>
        <p:spPr>
          <a:xfrm>
            <a:off x="352440" y="1120680"/>
            <a:ext cx="30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4"/>
          <p:cNvSpPr/>
          <p:nvPr/>
        </p:nvSpPr>
        <p:spPr>
          <a:xfrm>
            <a:off x="352440" y="3346560"/>
            <a:ext cx="30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24"/>
          <p:cNvSpPr/>
          <p:nvPr/>
        </p:nvSpPr>
        <p:spPr>
          <a:xfrm>
            <a:off x="2498400" y="3540240"/>
            <a:ext cx="31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25"/>
          <p:cNvSpPr/>
          <p:nvPr/>
        </p:nvSpPr>
        <p:spPr>
          <a:xfrm>
            <a:off x="2491920" y="2101680"/>
            <a:ext cx="31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08T08:46:25Z</dcterms:created>
  <dc:creator>acer</dc:creator>
  <dc:description/>
  <dc:language>en-US</dc:language>
  <cp:lastModifiedBy>acer</cp:lastModifiedBy>
  <dcterms:modified xsi:type="dcterms:W3CDTF">2014-01-04T00:05:58Z</dcterms:modified>
  <cp:revision>2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429</vt:lpwstr>
  </property>
</Properties>
</file>